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  <p:sldId id="258" r:id="rId4"/>
    <p:sldId id="257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2" d="100"/>
          <a:sy n="112" d="100"/>
        </p:scale>
        <p:origin x="64" y="-4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099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113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326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368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57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769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264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155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660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333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216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48AE0-BCF0-49CA-B9BF-0870ED591924}" type="datetimeFigureOut">
              <a:rPr lang="en-US" smtClean="0"/>
              <a:t>1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50BD4-77E2-4746-AC63-1F4623EB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931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Relationship Id="rId3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8 month old</a:t>
            </a:r>
            <a:endParaRPr lang="en-US" dirty="0"/>
          </a:p>
        </p:txBody>
      </p:sp>
      <p:pic>
        <p:nvPicPr>
          <p:cNvPr id="4" name="Content Placeholder 3" descr="Screen Shot 2016-12-21 at 3.40.09 PM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3319" r="-63319"/>
          <a:stretch>
            <a:fillRect/>
          </a:stretch>
        </p:blipFill>
        <p:spPr/>
      </p:pic>
    </p:spTree>
    <p:extLst>
      <p:ext uri="{BB962C8B-B14F-4D97-AF65-F5344CB8AC3E}">
        <p14:creationId xmlns:p14="http://schemas.microsoft.com/office/powerpoint/2010/main" val="38004051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6 y/o w enlarged heart due to myocarditis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2" t="591" r="14131" b="12491"/>
          <a:stretch/>
        </p:blipFill>
        <p:spPr>
          <a:xfrm>
            <a:off x="3341680" y="1504963"/>
            <a:ext cx="5049001" cy="5208449"/>
          </a:xfrm>
        </p:spPr>
      </p:pic>
    </p:spTree>
    <p:extLst>
      <p:ext uri="{BB962C8B-B14F-4D97-AF65-F5344CB8AC3E}">
        <p14:creationId xmlns:p14="http://schemas.microsoft.com/office/powerpoint/2010/main" val="776855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7yo female normal chest radiograph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45" t="22838" r="22565" b="31339"/>
          <a:stretch/>
        </p:blipFill>
        <p:spPr>
          <a:xfrm>
            <a:off x="4140200" y="1690688"/>
            <a:ext cx="4688482" cy="4572000"/>
          </a:xfrm>
        </p:spPr>
      </p:pic>
    </p:spTree>
    <p:extLst>
      <p:ext uri="{BB962C8B-B14F-4D97-AF65-F5344CB8AC3E}">
        <p14:creationId xmlns:p14="http://schemas.microsoft.com/office/powerpoint/2010/main" val="4396018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3 week old bronchiolitis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2" t="30000" r="28147" b="12593"/>
          <a:stretch/>
        </p:blipFill>
        <p:spPr>
          <a:xfrm>
            <a:off x="622301" y="1825625"/>
            <a:ext cx="4380271" cy="4572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78" t="12407" r="15741" b="21112"/>
          <a:stretch/>
        </p:blipFill>
        <p:spPr>
          <a:xfrm>
            <a:off x="6211476" y="1825625"/>
            <a:ext cx="4915855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32766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10 y/o </a:t>
            </a:r>
            <a:r>
              <a:rPr lang="en-US" smtClean="0"/>
              <a:t>normal radiograph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49" t="11164" r="23732" b="35717"/>
          <a:stretch/>
        </p:blipFill>
        <p:spPr>
          <a:xfrm>
            <a:off x="3187700" y="1690688"/>
            <a:ext cx="4571998" cy="4572000"/>
          </a:xfrm>
        </p:spPr>
      </p:pic>
    </p:spTree>
    <p:extLst>
      <p:ext uri="{BB962C8B-B14F-4D97-AF65-F5344CB8AC3E}">
        <p14:creationId xmlns:p14="http://schemas.microsoft.com/office/powerpoint/2010/main" val="3012239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2</TotalTime>
  <Words>28</Words>
  <Application>Microsoft Macintosh PowerPoint</Application>
  <PresentationFormat>Custom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8 month old</vt:lpstr>
      <vt:lpstr>6 y/o w enlarged heart due to myocarditis</vt:lpstr>
      <vt:lpstr>7yo female normal chest radiograph</vt:lpstr>
      <vt:lpstr>3 week old bronchiolitis</vt:lpstr>
      <vt:lpstr>10 y/o normal radiograph</vt:lpstr>
    </vt:vector>
  </TitlesOfParts>
  <Company>YNH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lva, Cicero</dc:creator>
  <cp:lastModifiedBy>Kevin Couloures</cp:lastModifiedBy>
  <cp:revision>7</cp:revision>
  <dcterms:created xsi:type="dcterms:W3CDTF">2016-07-25T18:29:41Z</dcterms:created>
  <dcterms:modified xsi:type="dcterms:W3CDTF">2016-12-21T22:06:20Z</dcterms:modified>
</cp:coreProperties>
</file>